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5898" r:id="rId2"/>
    <p:sldId id="5899" r:id="rId3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4E1FF"/>
    <a:srgbClr val="FF7E79"/>
    <a:srgbClr val="0096FF"/>
    <a:srgbClr val="0432FF"/>
    <a:srgbClr val="008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47"/>
    <p:restoredTop sz="96197"/>
  </p:normalViewPr>
  <p:slideViewPr>
    <p:cSldViewPr snapToGrid="0" snapToObjects="1">
      <p:cViewPr varScale="1">
        <p:scale>
          <a:sx n="105" d="100"/>
          <a:sy n="105" d="100"/>
        </p:scale>
        <p:origin x="135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47F076-C8C0-A741-9885-91F48CDCB025}" type="datetimeFigureOut">
              <a:rPr lang="en-US" smtClean="0"/>
              <a:t>2/24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3513" y="1143000"/>
            <a:ext cx="39909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40C79E-263A-6D45-9FCA-DF56B33AC5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9077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3508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308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7732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817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790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6521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2795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51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181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106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926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239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" name="Group 101">
            <a:extLst>
              <a:ext uri="{FF2B5EF4-FFF2-40B4-BE49-F238E27FC236}">
                <a16:creationId xmlns:a16="http://schemas.microsoft.com/office/drawing/2014/main" id="{8694248D-EFEB-4BD5-B15D-855A384EE251}"/>
              </a:ext>
            </a:extLst>
          </p:cNvPr>
          <p:cNvGrpSpPr/>
          <p:nvPr/>
        </p:nvGrpSpPr>
        <p:grpSpPr>
          <a:xfrm>
            <a:off x="344381" y="768995"/>
            <a:ext cx="2326703" cy="1896183"/>
            <a:chOff x="6815257" y="2558021"/>
            <a:chExt cx="4289182" cy="3379143"/>
          </a:xfrm>
        </p:grpSpPr>
        <p:pic>
          <p:nvPicPr>
            <p:cNvPr id="103" name="Picture 102">
              <a:extLst>
                <a:ext uri="{FF2B5EF4-FFF2-40B4-BE49-F238E27FC236}">
                  <a16:creationId xmlns:a16="http://schemas.microsoft.com/office/drawing/2014/main" id="{936EA259-3858-254A-60F5-341A064516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0238"/>
            <a:stretch/>
          </p:blipFill>
          <p:spPr>
            <a:xfrm>
              <a:off x="6815257" y="2558021"/>
              <a:ext cx="3764556" cy="3379143"/>
            </a:xfrm>
            <a:prstGeom prst="rect">
              <a:avLst/>
            </a:prstGeom>
          </p:spPr>
        </p:pic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0D8050D7-3C53-766E-BAF7-EC0581EE66E2}"/>
                </a:ext>
              </a:extLst>
            </p:cNvPr>
            <p:cNvSpPr txBox="1"/>
            <p:nvPr/>
          </p:nvSpPr>
          <p:spPr>
            <a:xfrm>
              <a:off x="8044149" y="4062685"/>
              <a:ext cx="825055" cy="4387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2152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1B8F7464-4FFB-1503-9471-C826A81DD8B6}"/>
                </a:ext>
              </a:extLst>
            </p:cNvPr>
            <p:cNvSpPr txBox="1"/>
            <p:nvPr/>
          </p:nvSpPr>
          <p:spPr>
            <a:xfrm>
              <a:off x="9631320" y="4062685"/>
              <a:ext cx="582740" cy="4387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4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7C7F7BF9-420E-48F5-B499-2510C799F587}"/>
                </a:ext>
              </a:extLst>
            </p:cNvPr>
            <p:cNvSpPr txBox="1"/>
            <p:nvPr/>
          </p:nvSpPr>
          <p:spPr>
            <a:xfrm>
              <a:off x="10042737" y="4062685"/>
              <a:ext cx="582740" cy="4387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7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A81FCED7-E437-5178-2771-8D0AA3DC4CF9}"/>
                </a:ext>
              </a:extLst>
            </p:cNvPr>
            <p:cNvSpPr txBox="1"/>
            <p:nvPr/>
          </p:nvSpPr>
          <p:spPr>
            <a:xfrm>
              <a:off x="7373775" y="3237885"/>
              <a:ext cx="2299636" cy="452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solidFill>
                    <a:srgbClr val="A42729"/>
                  </a:solidFill>
                </a:rPr>
                <a:t>Protein Candidates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8CD8A37B-F4BB-84CD-E8EC-A70347100575}"/>
                </a:ext>
              </a:extLst>
            </p:cNvPr>
            <p:cNvSpPr txBox="1"/>
            <p:nvPr/>
          </p:nvSpPr>
          <p:spPr>
            <a:xfrm>
              <a:off x="9951370" y="3099384"/>
              <a:ext cx="1153069" cy="7130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4F79A4"/>
                  </a:solidFill>
                </a:rPr>
                <a:t>SASP</a:t>
              </a:r>
            </a:p>
            <a:p>
              <a:pPr algn="ctr"/>
              <a:r>
                <a:rPr lang="en-US" sz="1000" b="1" dirty="0">
                  <a:solidFill>
                    <a:srgbClr val="4F79A4"/>
                  </a:solidFill>
                </a:rPr>
                <a:t>Markers</a:t>
              </a:r>
            </a:p>
          </p:txBody>
        </p:sp>
      </p:grpSp>
      <p:pic>
        <p:nvPicPr>
          <p:cNvPr id="2" name="Picture 1">
            <a:extLst>
              <a:ext uri="{FF2B5EF4-FFF2-40B4-BE49-F238E27FC236}">
                <a16:creationId xmlns:a16="http://schemas.microsoft.com/office/drawing/2014/main" id="{B4D2F47B-5319-F4D3-B9B7-FBE369C51D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03206" y="475644"/>
            <a:ext cx="5486397" cy="3429000"/>
          </a:xfrm>
          <a:prstGeom prst="rect">
            <a:avLst/>
          </a:prstGeom>
        </p:spPr>
      </p:pic>
      <p:sp>
        <p:nvSpPr>
          <p:cNvPr id="100" name="Title 2">
            <a:extLst>
              <a:ext uri="{FF2B5EF4-FFF2-40B4-BE49-F238E27FC236}">
                <a16:creationId xmlns:a16="http://schemas.microsoft.com/office/drawing/2014/main" id="{9F5A6309-FBFC-BA81-572E-0E39C5BC2074}"/>
              </a:ext>
            </a:extLst>
          </p:cNvPr>
          <p:cNvSpPr txBox="1">
            <a:spLocks/>
          </p:cNvSpPr>
          <p:nvPr/>
        </p:nvSpPr>
        <p:spPr>
          <a:xfrm>
            <a:off x="10039" y="379167"/>
            <a:ext cx="5926838" cy="245377"/>
          </a:xfrm>
          <a:prstGeom prst="rect">
            <a:avLst/>
          </a:prstGeom>
        </p:spPr>
        <p:txBody>
          <a:bodyPr vert="horz" lIns="70658" tIns="35329" rIns="70658" bIns="35329" rtlCol="0" anchor="ctr">
            <a:no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379" b="1">
                <a:latin typeface="+mn-lt"/>
                <a:cs typeface="Calibri" panose="020F0502020204030204" pitchFamily="34" charset="0"/>
              </a:rPr>
              <a:t>Senescence Protein Markers are Regulated in Injured Kidney</a:t>
            </a:r>
            <a:endParaRPr lang="en-US" sz="1379" b="1" dirty="0">
              <a:solidFill>
                <a:srgbClr val="009051"/>
              </a:solidFill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01" name="Text Placeholder 3">
            <a:extLst>
              <a:ext uri="{FF2B5EF4-FFF2-40B4-BE49-F238E27FC236}">
                <a16:creationId xmlns:a16="http://schemas.microsoft.com/office/drawing/2014/main" id="{1FD94F21-169F-EC41-C069-45BB6F0668B3}"/>
              </a:ext>
            </a:extLst>
          </p:cNvPr>
          <p:cNvSpPr txBox="1">
            <a:spLocks/>
          </p:cNvSpPr>
          <p:nvPr/>
        </p:nvSpPr>
        <p:spPr>
          <a:xfrm>
            <a:off x="50210" y="628230"/>
            <a:ext cx="5578686" cy="140765"/>
          </a:xfrm>
          <a:prstGeom prst="rect">
            <a:avLst/>
          </a:prstGeom>
        </p:spPr>
        <p:txBody>
          <a:bodyPr vert="horz" lIns="70658" tIns="35329" rIns="70658" bIns="35329" rtlCol="0" anchor="ctr">
            <a:noAutofit/>
          </a:bodyPr>
          <a:lstStyle>
            <a:defPPr>
              <a:defRPr lang="en-US"/>
            </a:defPPr>
            <a:lvl1pPr marL="0" algn="r" defTabSz="457200" rtl="0" eaLnBrk="1" latinLnBrk="0" hangingPunct="1">
              <a:defRPr sz="102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82" dirty="0"/>
              <a:t>4 </a:t>
            </a:r>
            <a:r>
              <a:rPr lang="en-US" sz="1182" dirty="0" err="1"/>
              <a:t>inj</a:t>
            </a:r>
            <a:r>
              <a:rPr lang="en-US" sz="1182" dirty="0"/>
              <a:t> / 4 control Zeno SWATH DIA (120 min gradient)</a:t>
            </a:r>
          </a:p>
        </p:txBody>
      </p:sp>
      <p:grpSp>
        <p:nvGrpSpPr>
          <p:cNvPr id="110" name="Group 109">
            <a:extLst>
              <a:ext uri="{FF2B5EF4-FFF2-40B4-BE49-F238E27FC236}">
                <a16:creationId xmlns:a16="http://schemas.microsoft.com/office/drawing/2014/main" id="{BEAA7A1F-1778-6C40-AFBC-75F2480BA984}"/>
              </a:ext>
            </a:extLst>
          </p:cNvPr>
          <p:cNvGrpSpPr/>
          <p:nvPr/>
        </p:nvGrpSpPr>
        <p:grpSpPr>
          <a:xfrm>
            <a:off x="414699" y="2748687"/>
            <a:ext cx="1069509" cy="1244725"/>
            <a:chOff x="-404892" y="4094607"/>
            <a:chExt cx="2171092" cy="2526778"/>
          </a:xfrm>
        </p:grpSpPr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1223CAC4-894F-7199-78CE-C98774FDDF07}"/>
                </a:ext>
              </a:extLst>
            </p:cNvPr>
            <p:cNvSpPr txBox="1"/>
            <p:nvPr/>
          </p:nvSpPr>
          <p:spPr>
            <a:xfrm>
              <a:off x="805599" y="4494127"/>
              <a:ext cx="960601" cy="21272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87" dirty="0"/>
                <a:t>Akr1a</a:t>
              </a:r>
              <a:br>
                <a:rPr lang="en-US" sz="887" dirty="0"/>
              </a:br>
              <a:r>
                <a:rPr lang="en-US" sz="887" dirty="0"/>
                <a:t>Mdh1</a:t>
              </a:r>
              <a:br>
                <a:rPr lang="en-US" sz="887" dirty="0"/>
              </a:br>
              <a:r>
                <a:rPr lang="en-US" sz="887" dirty="0"/>
                <a:t>Sod1</a:t>
              </a:r>
              <a:br>
                <a:rPr lang="en-US" sz="887" dirty="0"/>
              </a:br>
              <a:r>
                <a:rPr lang="en-US" sz="887" dirty="0"/>
                <a:t>Mdh2</a:t>
              </a:r>
            </a:p>
            <a:p>
              <a:r>
                <a:rPr lang="en-US" sz="887" dirty="0"/>
                <a:t>Hspe1</a:t>
              </a:r>
            </a:p>
            <a:p>
              <a:r>
                <a:rPr lang="en-US" sz="887" dirty="0" err="1"/>
                <a:t>Aldoc</a:t>
              </a:r>
              <a:endParaRPr lang="en-US" sz="887" dirty="0"/>
            </a:p>
            <a:p>
              <a:r>
                <a:rPr lang="en-US" sz="887" dirty="0"/>
                <a:t>Glo1</a:t>
              </a:r>
            </a:p>
          </p:txBody>
        </p:sp>
        <p:sp>
          <p:nvSpPr>
            <p:cNvPr id="112" name="Arrow: Right 18">
              <a:extLst>
                <a:ext uri="{FF2B5EF4-FFF2-40B4-BE49-F238E27FC236}">
                  <a16:creationId xmlns:a16="http://schemas.microsoft.com/office/drawing/2014/main" id="{54FA7D63-E7C9-79A4-C9E8-4E3AF00F5B95}"/>
                </a:ext>
              </a:extLst>
            </p:cNvPr>
            <p:cNvSpPr/>
            <p:nvPr/>
          </p:nvSpPr>
          <p:spPr>
            <a:xfrm rot="5400000">
              <a:off x="-474410" y="4164125"/>
              <a:ext cx="300846" cy="161810"/>
            </a:xfrm>
            <a:prstGeom prst="rightArrow">
              <a:avLst/>
            </a:prstGeom>
            <a:solidFill>
              <a:srgbClr val="1D0CF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88" dirty="0"/>
            </a:p>
          </p:txBody>
        </p:sp>
      </p:grpSp>
      <p:sp>
        <p:nvSpPr>
          <p:cNvPr id="113" name="Arrow: Right 14">
            <a:extLst>
              <a:ext uri="{FF2B5EF4-FFF2-40B4-BE49-F238E27FC236}">
                <a16:creationId xmlns:a16="http://schemas.microsoft.com/office/drawing/2014/main" id="{AC59107D-51BA-82AA-B28B-CC7C435D4602}"/>
              </a:ext>
            </a:extLst>
          </p:cNvPr>
          <p:cNvSpPr/>
          <p:nvPr/>
        </p:nvSpPr>
        <p:spPr>
          <a:xfrm rot="16200000">
            <a:off x="2775927" y="885609"/>
            <a:ext cx="148201" cy="79711"/>
          </a:xfrm>
          <a:prstGeom prst="rightArrow">
            <a:avLst/>
          </a:prstGeom>
          <a:solidFill>
            <a:srgbClr val="DE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87"/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23077C24-9A88-FBDB-14DB-17F4D08324E6}"/>
              </a:ext>
            </a:extLst>
          </p:cNvPr>
          <p:cNvSpPr txBox="1"/>
          <p:nvPr/>
        </p:nvSpPr>
        <p:spPr>
          <a:xfrm>
            <a:off x="3926057" y="1021871"/>
            <a:ext cx="587020" cy="14574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7" dirty="0" err="1"/>
              <a:t>Tnc</a:t>
            </a:r>
            <a:endParaRPr lang="en-US" sz="887" dirty="0"/>
          </a:p>
          <a:p>
            <a:r>
              <a:rPr lang="en-US" sz="887" dirty="0"/>
              <a:t>Fn1</a:t>
            </a:r>
          </a:p>
          <a:p>
            <a:r>
              <a:rPr lang="en-US" sz="887" dirty="0"/>
              <a:t>Col12a1</a:t>
            </a:r>
          </a:p>
          <a:p>
            <a:r>
              <a:rPr lang="en-US" sz="887" dirty="0"/>
              <a:t>Lgals3bp</a:t>
            </a:r>
          </a:p>
          <a:p>
            <a:r>
              <a:rPr lang="en-US" sz="887" dirty="0"/>
              <a:t>Qsox1</a:t>
            </a:r>
          </a:p>
          <a:p>
            <a:r>
              <a:rPr lang="en-US" sz="887" dirty="0"/>
              <a:t>Lgals1</a:t>
            </a:r>
          </a:p>
          <a:p>
            <a:r>
              <a:rPr lang="en-US" sz="887" dirty="0" err="1"/>
              <a:t>Alcam</a:t>
            </a:r>
            <a:endParaRPr lang="en-US" sz="887" dirty="0"/>
          </a:p>
          <a:p>
            <a:r>
              <a:rPr lang="en-US" sz="887" dirty="0" err="1"/>
              <a:t>Bgn</a:t>
            </a:r>
            <a:endParaRPr lang="en-US" sz="887" dirty="0"/>
          </a:p>
          <a:p>
            <a:r>
              <a:rPr lang="en-US" sz="887" dirty="0" err="1"/>
              <a:t>Ctsd</a:t>
            </a:r>
            <a:endParaRPr lang="en-US" sz="887" dirty="0"/>
          </a:p>
          <a:p>
            <a:r>
              <a:rPr lang="en-US" sz="887" dirty="0"/>
              <a:t>Emilin1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91411FE2-1070-C2E7-647A-02B1E78AA171}"/>
              </a:ext>
            </a:extLst>
          </p:cNvPr>
          <p:cNvSpPr txBox="1"/>
          <p:nvPr/>
        </p:nvSpPr>
        <p:spPr>
          <a:xfrm>
            <a:off x="2636098" y="1020021"/>
            <a:ext cx="595035" cy="26860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7" dirty="0"/>
              <a:t>Serpinh1</a:t>
            </a:r>
          </a:p>
          <a:p>
            <a:r>
              <a:rPr lang="en-US" sz="887" dirty="0"/>
              <a:t>Actn1</a:t>
            </a:r>
          </a:p>
          <a:p>
            <a:r>
              <a:rPr lang="en-US" sz="887" dirty="0"/>
              <a:t>Plec</a:t>
            </a:r>
          </a:p>
          <a:p>
            <a:r>
              <a:rPr lang="en-US" sz="887" dirty="0"/>
              <a:t>Mrc2</a:t>
            </a:r>
          </a:p>
          <a:p>
            <a:r>
              <a:rPr lang="en-US" sz="887" dirty="0" err="1"/>
              <a:t>Flna</a:t>
            </a:r>
            <a:endParaRPr lang="en-US" sz="887" dirty="0"/>
          </a:p>
          <a:p>
            <a:r>
              <a:rPr lang="en-US" sz="887" dirty="0"/>
              <a:t>Pdlim1</a:t>
            </a:r>
          </a:p>
          <a:p>
            <a:r>
              <a:rPr lang="en-US" sz="887" dirty="0"/>
              <a:t>Vim</a:t>
            </a:r>
          </a:p>
          <a:p>
            <a:r>
              <a:rPr lang="en-US" sz="887" dirty="0"/>
              <a:t>Cd44</a:t>
            </a:r>
          </a:p>
          <a:p>
            <a:r>
              <a:rPr lang="en-US" sz="887" dirty="0"/>
              <a:t>Fkbp10</a:t>
            </a:r>
          </a:p>
          <a:p>
            <a:r>
              <a:rPr lang="en-US" sz="887" dirty="0"/>
              <a:t>Sh3bgrl3</a:t>
            </a:r>
          </a:p>
          <a:p>
            <a:r>
              <a:rPr lang="en-US" sz="887" dirty="0"/>
              <a:t>Plod3</a:t>
            </a:r>
          </a:p>
          <a:p>
            <a:r>
              <a:rPr lang="en-US" sz="887" dirty="0"/>
              <a:t>Myh9</a:t>
            </a:r>
          </a:p>
          <a:p>
            <a:r>
              <a:rPr lang="en-US" sz="887" dirty="0"/>
              <a:t>Tagln2</a:t>
            </a:r>
          </a:p>
          <a:p>
            <a:r>
              <a:rPr lang="en-US" sz="887" dirty="0" err="1"/>
              <a:t>Postn</a:t>
            </a:r>
            <a:endParaRPr lang="en-US" sz="887" dirty="0"/>
          </a:p>
          <a:p>
            <a:r>
              <a:rPr lang="en-US" sz="887" dirty="0" err="1"/>
              <a:t>Hexa</a:t>
            </a:r>
            <a:endParaRPr lang="en-US" sz="887" dirty="0"/>
          </a:p>
          <a:p>
            <a:r>
              <a:rPr lang="en-US" sz="887" dirty="0"/>
              <a:t>Pfn1</a:t>
            </a:r>
          </a:p>
          <a:p>
            <a:r>
              <a:rPr lang="en-US" sz="887" dirty="0"/>
              <a:t>Npm1</a:t>
            </a:r>
          </a:p>
          <a:p>
            <a:r>
              <a:rPr lang="en-US" sz="887" dirty="0"/>
              <a:t>Col6a2</a:t>
            </a:r>
          </a:p>
          <a:p>
            <a:r>
              <a:rPr lang="en-US" sz="887" dirty="0"/>
              <a:t>Myl12b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C1F1896C-DE9E-CA19-90B3-C9A8D35D7255}"/>
              </a:ext>
            </a:extLst>
          </p:cNvPr>
          <p:cNvSpPr txBox="1"/>
          <p:nvPr/>
        </p:nvSpPr>
        <p:spPr>
          <a:xfrm>
            <a:off x="3135411" y="1020021"/>
            <a:ext cx="516488" cy="26860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7" dirty="0" err="1"/>
              <a:t>Ctsb</a:t>
            </a:r>
            <a:endParaRPr lang="en-US" sz="887" dirty="0"/>
          </a:p>
          <a:p>
            <a:r>
              <a:rPr lang="en-US" sz="887" dirty="0"/>
              <a:t>Myl6</a:t>
            </a:r>
          </a:p>
          <a:p>
            <a:r>
              <a:rPr lang="en-US" sz="887" dirty="0" err="1"/>
              <a:t>Calu</a:t>
            </a:r>
            <a:endParaRPr lang="en-US" sz="887" dirty="0"/>
          </a:p>
          <a:p>
            <a:r>
              <a:rPr lang="en-US" sz="887" dirty="0"/>
              <a:t>Col6a1</a:t>
            </a:r>
          </a:p>
          <a:p>
            <a:r>
              <a:rPr lang="en-US" sz="887" dirty="0"/>
              <a:t>Plod1</a:t>
            </a:r>
          </a:p>
          <a:p>
            <a:r>
              <a:rPr lang="en-US" sz="887" dirty="0"/>
              <a:t>Psme1</a:t>
            </a:r>
          </a:p>
          <a:p>
            <a:r>
              <a:rPr lang="en-US" sz="887" dirty="0"/>
              <a:t>Cap1</a:t>
            </a:r>
          </a:p>
          <a:p>
            <a:r>
              <a:rPr lang="en-US" sz="887" dirty="0" err="1"/>
              <a:t>Ctsz</a:t>
            </a:r>
            <a:endParaRPr lang="en-US" sz="887" dirty="0"/>
          </a:p>
          <a:p>
            <a:r>
              <a:rPr lang="en-US" sz="887" dirty="0"/>
              <a:t>Lqgap1</a:t>
            </a:r>
          </a:p>
          <a:p>
            <a:r>
              <a:rPr lang="en-US" sz="887" dirty="0"/>
              <a:t>Gsto1</a:t>
            </a:r>
          </a:p>
          <a:p>
            <a:r>
              <a:rPr lang="en-US" sz="887" dirty="0"/>
              <a:t>Tmp2</a:t>
            </a:r>
          </a:p>
          <a:p>
            <a:r>
              <a:rPr lang="en-US" sz="887" dirty="0"/>
              <a:t>Wdr1</a:t>
            </a:r>
          </a:p>
          <a:p>
            <a:r>
              <a:rPr lang="en-US" sz="887" dirty="0" err="1"/>
              <a:t>Vcl</a:t>
            </a:r>
            <a:endParaRPr lang="en-US" sz="887" dirty="0"/>
          </a:p>
          <a:p>
            <a:r>
              <a:rPr lang="en-US" sz="887" dirty="0" err="1"/>
              <a:t>Flnb</a:t>
            </a:r>
            <a:endParaRPr lang="en-US" sz="887" dirty="0"/>
          </a:p>
          <a:p>
            <a:r>
              <a:rPr lang="en-US" sz="887" dirty="0"/>
              <a:t>App</a:t>
            </a:r>
          </a:p>
          <a:p>
            <a:r>
              <a:rPr lang="en-US" sz="887" dirty="0" err="1"/>
              <a:t>Agrn</a:t>
            </a:r>
            <a:endParaRPr lang="en-US" sz="887" dirty="0"/>
          </a:p>
          <a:p>
            <a:r>
              <a:rPr lang="en-US" sz="887" dirty="0" err="1"/>
              <a:t>Psap</a:t>
            </a:r>
            <a:endParaRPr lang="en-US" sz="887" dirty="0"/>
          </a:p>
          <a:p>
            <a:r>
              <a:rPr lang="en-US" sz="887" dirty="0"/>
              <a:t>Cor1c</a:t>
            </a:r>
          </a:p>
          <a:p>
            <a:r>
              <a:rPr lang="en-US" sz="887" dirty="0"/>
              <a:t>Dpsyl2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DD54C4A0-8678-2D55-39D0-5472497823A3}"/>
              </a:ext>
            </a:extLst>
          </p:cNvPr>
          <p:cNvSpPr txBox="1"/>
          <p:nvPr/>
        </p:nvSpPr>
        <p:spPr>
          <a:xfrm>
            <a:off x="3542708" y="1020021"/>
            <a:ext cx="702436" cy="26860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7" dirty="0"/>
              <a:t>Eif4a1</a:t>
            </a:r>
          </a:p>
          <a:p>
            <a:r>
              <a:rPr lang="en-US" sz="887" dirty="0"/>
              <a:t>Hmgb1</a:t>
            </a:r>
          </a:p>
          <a:p>
            <a:r>
              <a:rPr lang="en-US" sz="887" dirty="0"/>
              <a:t>Msn</a:t>
            </a:r>
          </a:p>
          <a:p>
            <a:r>
              <a:rPr lang="en-US" sz="887" dirty="0" err="1"/>
              <a:t>Gsn</a:t>
            </a:r>
            <a:endParaRPr lang="en-US" sz="887" dirty="0"/>
          </a:p>
          <a:p>
            <a:r>
              <a:rPr lang="en-US" sz="887" dirty="0"/>
              <a:t>Fkbp1a</a:t>
            </a:r>
          </a:p>
          <a:p>
            <a:r>
              <a:rPr lang="en-US" sz="887" dirty="0" err="1"/>
              <a:t>Actb</a:t>
            </a:r>
            <a:endParaRPr lang="en-US" sz="887" dirty="0"/>
          </a:p>
          <a:p>
            <a:r>
              <a:rPr lang="en-US" sz="887" dirty="0"/>
              <a:t>Lasp1</a:t>
            </a:r>
          </a:p>
          <a:p>
            <a:r>
              <a:rPr lang="en-US" sz="887" dirty="0"/>
              <a:t>Cts3</a:t>
            </a:r>
          </a:p>
          <a:p>
            <a:r>
              <a:rPr lang="en-US" sz="887" dirty="0"/>
              <a:t>Tln1</a:t>
            </a:r>
          </a:p>
          <a:p>
            <a:r>
              <a:rPr lang="en-US" sz="887" dirty="0" err="1"/>
              <a:t>Tkt</a:t>
            </a:r>
            <a:endParaRPr lang="en-US" sz="887" dirty="0"/>
          </a:p>
          <a:p>
            <a:r>
              <a:rPr lang="en-US" sz="887" dirty="0" err="1"/>
              <a:t>Aars</a:t>
            </a:r>
            <a:endParaRPr lang="en-US" sz="887" dirty="0"/>
          </a:p>
          <a:p>
            <a:r>
              <a:rPr lang="en-US" sz="887" dirty="0"/>
              <a:t>Hspg2</a:t>
            </a:r>
          </a:p>
          <a:p>
            <a:r>
              <a:rPr lang="en-US" sz="887" dirty="0"/>
              <a:t>Tpd52l2</a:t>
            </a:r>
          </a:p>
          <a:p>
            <a:r>
              <a:rPr lang="en-US" sz="887" dirty="0"/>
              <a:t>Psma3</a:t>
            </a:r>
          </a:p>
          <a:p>
            <a:r>
              <a:rPr lang="en-US" sz="887" dirty="0" err="1"/>
              <a:t>Ywhaq</a:t>
            </a:r>
            <a:endParaRPr lang="en-US" sz="887" dirty="0"/>
          </a:p>
          <a:p>
            <a:r>
              <a:rPr lang="en-US" sz="887" dirty="0" err="1"/>
              <a:t>Hexb</a:t>
            </a:r>
            <a:endParaRPr lang="en-US" sz="887" dirty="0"/>
          </a:p>
          <a:p>
            <a:r>
              <a:rPr lang="en-US" sz="887" dirty="0"/>
              <a:t>Hspa1b</a:t>
            </a:r>
          </a:p>
          <a:p>
            <a:r>
              <a:rPr lang="en-US" sz="887" dirty="0"/>
              <a:t>Hnrnpa2b1</a:t>
            </a:r>
          </a:p>
          <a:p>
            <a:r>
              <a:rPr lang="en-US" sz="887" dirty="0"/>
              <a:t>Rcn1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2E213BA0-9710-55F0-BF23-7FE2FD214776}"/>
              </a:ext>
            </a:extLst>
          </p:cNvPr>
          <p:cNvSpPr txBox="1"/>
          <p:nvPr/>
        </p:nvSpPr>
        <p:spPr>
          <a:xfrm>
            <a:off x="1618813" y="4782732"/>
            <a:ext cx="5604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Injury</a:t>
            </a:r>
          </a:p>
        </p:txBody>
      </p:sp>
      <p:grpSp>
        <p:nvGrpSpPr>
          <p:cNvPr id="119" name="Group 118">
            <a:extLst>
              <a:ext uri="{FF2B5EF4-FFF2-40B4-BE49-F238E27FC236}">
                <a16:creationId xmlns:a16="http://schemas.microsoft.com/office/drawing/2014/main" id="{8305A2C9-74F2-48BA-2E0C-DB9EEF2A2E64}"/>
              </a:ext>
            </a:extLst>
          </p:cNvPr>
          <p:cNvGrpSpPr/>
          <p:nvPr/>
        </p:nvGrpSpPr>
        <p:grpSpPr>
          <a:xfrm>
            <a:off x="657539" y="4395375"/>
            <a:ext cx="783016" cy="915179"/>
            <a:chOff x="10985500" y="1262657"/>
            <a:chExt cx="625929" cy="862926"/>
          </a:xfrm>
        </p:grpSpPr>
        <p:pic>
          <p:nvPicPr>
            <p:cNvPr id="120" name="Picture 119">
              <a:extLst>
                <a:ext uri="{FF2B5EF4-FFF2-40B4-BE49-F238E27FC236}">
                  <a16:creationId xmlns:a16="http://schemas.microsoft.com/office/drawing/2014/main" id="{EEC9C073-0050-82D9-0F6E-446090DF87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28" t="26554" r="74295" b="56266"/>
            <a:stretch/>
          </p:blipFill>
          <p:spPr>
            <a:xfrm>
              <a:off x="10985500" y="1344055"/>
              <a:ext cx="508419" cy="781528"/>
            </a:xfrm>
            <a:prstGeom prst="rect">
              <a:avLst/>
            </a:prstGeom>
          </p:spPr>
        </p:pic>
        <p:sp>
          <p:nvSpPr>
            <p:cNvPr id="121" name="Lightning Bolt 120">
              <a:extLst>
                <a:ext uri="{FF2B5EF4-FFF2-40B4-BE49-F238E27FC236}">
                  <a16:creationId xmlns:a16="http://schemas.microsoft.com/office/drawing/2014/main" id="{BC1EA25E-9AE2-70BB-183C-FCFD150305DA}"/>
                </a:ext>
              </a:extLst>
            </p:cNvPr>
            <p:cNvSpPr/>
            <p:nvPr/>
          </p:nvSpPr>
          <p:spPr>
            <a:xfrm flipH="1">
              <a:off x="11321205" y="1262657"/>
              <a:ext cx="290224" cy="536281"/>
            </a:xfrm>
            <a:prstGeom prst="lightningBolt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85" dirty="0"/>
            </a:p>
          </p:txBody>
        </p:sp>
      </p:grpSp>
      <p:sp>
        <p:nvSpPr>
          <p:cNvPr id="125" name="TextBox 124">
            <a:extLst>
              <a:ext uri="{FF2B5EF4-FFF2-40B4-BE49-F238E27FC236}">
                <a16:creationId xmlns:a16="http://schemas.microsoft.com/office/drawing/2014/main" id="{13C24EDE-9054-FECB-0B24-5DC947A06B2E}"/>
              </a:ext>
            </a:extLst>
          </p:cNvPr>
          <p:cNvSpPr txBox="1"/>
          <p:nvPr/>
        </p:nvSpPr>
        <p:spPr>
          <a:xfrm>
            <a:off x="1438828" y="5797667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Senescence</a:t>
            </a:r>
          </a:p>
        </p:txBody>
      </p:sp>
      <p:grpSp>
        <p:nvGrpSpPr>
          <p:cNvPr id="126" name="Group 125">
            <a:extLst>
              <a:ext uri="{FF2B5EF4-FFF2-40B4-BE49-F238E27FC236}">
                <a16:creationId xmlns:a16="http://schemas.microsoft.com/office/drawing/2014/main" id="{05EA22EE-BADB-7A9C-DDBD-3F7B285A0071}"/>
              </a:ext>
            </a:extLst>
          </p:cNvPr>
          <p:cNvGrpSpPr/>
          <p:nvPr/>
        </p:nvGrpSpPr>
        <p:grpSpPr>
          <a:xfrm>
            <a:off x="1802078" y="6051220"/>
            <a:ext cx="166625" cy="815859"/>
            <a:chOff x="9232900" y="2201271"/>
            <a:chExt cx="152400" cy="381513"/>
          </a:xfrm>
        </p:grpSpPr>
        <p:cxnSp>
          <p:nvCxnSpPr>
            <p:cNvPr id="127" name="Straight Arrow Connector 126">
              <a:extLst>
                <a:ext uri="{FF2B5EF4-FFF2-40B4-BE49-F238E27FC236}">
                  <a16:creationId xmlns:a16="http://schemas.microsoft.com/office/drawing/2014/main" id="{A516D1F0-5EB1-ADCD-7E78-697E5E83D6BB}"/>
                </a:ext>
              </a:extLst>
            </p:cNvPr>
            <p:cNvCxnSpPr>
              <a:cxnSpLocks/>
            </p:cNvCxnSpPr>
            <p:nvPr/>
          </p:nvCxnSpPr>
          <p:spPr>
            <a:xfrm>
              <a:off x="9232900" y="2201271"/>
              <a:ext cx="0" cy="381513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" name="Straight Arrow Connector 127">
              <a:extLst>
                <a:ext uri="{FF2B5EF4-FFF2-40B4-BE49-F238E27FC236}">
                  <a16:creationId xmlns:a16="http://schemas.microsoft.com/office/drawing/2014/main" id="{584B2089-0F04-A0A7-40B7-AFD6C376010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385300" y="2201271"/>
              <a:ext cx="0" cy="381513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29" name="TextBox 128">
            <a:extLst>
              <a:ext uri="{FF2B5EF4-FFF2-40B4-BE49-F238E27FC236}">
                <a16:creationId xmlns:a16="http://schemas.microsoft.com/office/drawing/2014/main" id="{CA423219-222B-8EA5-4F2B-0380262233A6}"/>
              </a:ext>
            </a:extLst>
          </p:cNvPr>
          <p:cNvSpPr txBox="1"/>
          <p:nvPr/>
        </p:nvSpPr>
        <p:spPr>
          <a:xfrm>
            <a:off x="1625578" y="6812601"/>
            <a:ext cx="5469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Aging</a:t>
            </a:r>
          </a:p>
        </p:txBody>
      </p:sp>
      <p:pic>
        <p:nvPicPr>
          <p:cNvPr id="130" name="Picture 2" descr="Quercetin - Wikipedia">
            <a:extLst>
              <a:ext uri="{FF2B5EF4-FFF2-40B4-BE49-F238E27FC236}">
                <a16:creationId xmlns:a16="http://schemas.microsoft.com/office/drawing/2014/main" id="{D79D8DE8-F587-3CE4-926B-2BED309288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22342" y="5140267"/>
            <a:ext cx="1386026" cy="9343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1" name="TextBox 130">
            <a:extLst>
              <a:ext uri="{FF2B5EF4-FFF2-40B4-BE49-F238E27FC236}">
                <a16:creationId xmlns:a16="http://schemas.microsoft.com/office/drawing/2014/main" id="{C22E9460-92A6-36D0-6BEE-F2B6F1F9E4C8}"/>
              </a:ext>
            </a:extLst>
          </p:cNvPr>
          <p:cNvSpPr txBox="1"/>
          <p:nvPr/>
        </p:nvSpPr>
        <p:spPr>
          <a:xfrm>
            <a:off x="1921866" y="4317557"/>
            <a:ext cx="14991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ould a </a:t>
            </a:r>
            <a:r>
              <a:rPr lang="en-US" sz="1100" dirty="0" err="1"/>
              <a:t>senolytic</a:t>
            </a:r>
            <a:r>
              <a:rPr lang="en-US" sz="1100" dirty="0"/>
              <a:t> help?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BBFF3F4A-3D82-A78E-03A9-00D3D5FB1A2E}"/>
              </a:ext>
            </a:extLst>
          </p:cNvPr>
          <p:cNvSpPr txBox="1"/>
          <p:nvPr/>
        </p:nvSpPr>
        <p:spPr>
          <a:xfrm>
            <a:off x="2126111" y="4116922"/>
            <a:ext cx="11112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Interventions?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6D9EB5D6-2DCA-667A-5968-D57787AD3E86}"/>
              </a:ext>
            </a:extLst>
          </p:cNvPr>
          <p:cNvSpPr txBox="1"/>
          <p:nvPr/>
        </p:nvSpPr>
        <p:spPr>
          <a:xfrm>
            <a:off x="2812988" y="6206262"/>
            <a:ext cx="692818" cy="2439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85" dirty="0"/>
              <a:t>Querceti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BD6452B-B0C7-B13D-FF13-27AC7B8A4AC5}"/>
              </a:ext>
            </a:extLst>
          </p:cNvPr>
          <p:cNvSpPr txBox="1"/>
          <p:nvPr/>
        </p:nvSpPr>
        <p:spPr>
          <a:xfrm>
            <a:off x="5807575" y="345074"/>
            <a:ext cx="34144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own-Regulated SASP Marker Biological Processe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6367F0C-031D-30A1-E0B6-8717385AD78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03206" y="4049744"/>
            <a:ext cx="5486399" cy="3429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4CC5459-CCC1-8E51-45E5-395CBD38C5A5}"/>
              </a:ext>
            </a:extLst>
          </p:cNvPr>
          <p:cNvSpPr txBox="1"/>
          <p:nvPr/>
        </p:nvSpPr>
        <p:spPr>
          <a:xfrm>
            <a:off x="5905198" y="3875814"/>
            <a:ext cx="32192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Up-Regulated SASP Marker Biological Process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6BF180F-1364-9DC8-AE6C-479CCA512559}"/>
              </a:ext>
            </a:extLst>
          </p:cNvPr>
          <p:cNvSpPr txBox="1"/>
          <p:nvPr/>
        </p:nvSpPr>
        <p:spPr>
          <a:xfrm>
            <a:off x="203685" y="94797"/>
            <a:ext cx="987835" cy="3063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91" dirty="0"/>
              <a:t>Figure S-0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76A9EE1-AC0F-5397-046C-2B9FAA2557F4}"/>
              </a:ext>
            </a:extLst>
          </p:cNvPr>
          <p:cNvSpPr txBox="1"/>
          <p:nvPr/>
        </p:nvSpPr>
        <p:spPr>
          <a:xfrm>
            <a:off x="2867234" y="803583"/>
            <a:ext cx="1897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p-regulated SASP Marker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2AF97BA-A10B-A924-8946-384911401B14}"/>
              </a:ext>
            </a:extLst>
          </p:cNvPr>
          <p:cNvSpPr txBox="1"/>
          <p:nvPr/>
        </p:nvSpPr>
        <p:spPr>
          <a:xfrm>
            <a:off x="490048" y="2674938"/>
            <a:ext cx="21643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own-regulated SASP Markers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422D5E36-2375-3E1A-F29C-53142A1D866C}"/>
              </a:ext>
            </a:extLst>
          </p:cNvPr>
          <p:cNvGrpSpPr/>
          <p:nvPr/>
        </p:nvGrpSpPr>
        <p:grpSpPr>
          <a:xfrm>
            <a:off x="1802079" y="5031313"/>
            <a:ext cx="166625" cy="815859"/>
            <a:chOff x="9232900" y="2201271"/>
            <a:chExt cx="152400" cy="381513"/>
          </a:xfrm>
        </p:grpSpPr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2AA02C96-3EAB-AF75-C070-1886B95444C1}"/>
                </a:ext>
              </a:extLst>
            </p:cNvPr>
            <p:cNvCxnSpPr>
              <a:cxnSpLocks/>
            </p:cNvCxnSpPr>
            <p:nvPr/>
          </p:nvCxnSpPr>
          <p:spPr>
            <a:xfrm>
              <a:off x="9232900" y="2201271"/>
              <a:ext cx="0" cy="381513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277EF126-CB47-CFB2-362A-7B1E344DCA2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385300" y="2201271"/>
              <a:ext cx="0" cy="381513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8533722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18" grpId="0"/>
      <p:bldP spid="125" grpId="0"/>
      <p:bldP spid="129" grpId="0"/>
      <p:bldP spid="131" grpId="0"/>
      <p:bldP spid="132" grpId="0"/>
      <p:bldP spid="134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B3227C3-7108-0C6F-81A1-462B85D1BE8E}"/>
              </a:ext>
            </a:extLst>
          </p:cNvPr>
          <p:cNvSpPr txBox="1"/>
          <p:nvPr/>
        </p:nvSpPr>
        <p:spPr>
          <a:xfrm>
            <a:off x="426720" y="561478"/>
            <a:ext cx="9192768" cy="25351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2 Fig. Overlap in significantly altered proteins and the core SASP demonstrates upregulation of processes involved in wound healing.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is shows the overlap of proteins identified in the DIA data collected using an 80 variable window method and 120-min chromatographic gradient and the core senescence associated secretory phenotype (SASP) proteins. The core SASP proteins identified in the dataset are listed.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iological processes for up- and down-regulated SASP markers are shown in dot plots.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4175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842</TotalTime>
  <Words>214</Words>
  <Application>Microsoft Macintosh PowerPoint</Application>
  <PresentationFormat>Custom</PresentationFormat>
  <Paragraphs>9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in Figures</dc:title>
  <dc:creator>Jordan Burton</dc:creator>
  <cp:lastModifiedBy>Jordan Burton</cp:lastModifiedBy>
  <cp:revision>43</cp:revision>
  <cp:lastPrinted>2022-06-23T21:58:45Z</cp:lastPrinted>
  <dcterms:created xsi:type="dcterms:W3CDTF">2022-06-13T21:49:24Z</dcterms:created>
  <dcterms:modified xsi:type="dcterms:W3CDTF">2023-02-25T01:07:19Z</dcterms:modified>
</cp:coreProperties>
</file>